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8" r:id="rId2"/>
    <p:sldId id="265" r:id="rId3"/>
    <p:sldId id="26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583" autoAdjust="0"/>
    <p:restoredTop sz="87601" autoAdjust="0"/>
  </p:normalViewPr>
  <p:slideViewPr>
    <p:cSldViewPr snapToGrid="0">
      <p:cViewPr>
        <p:scale>
          <a:sx n="90" d="100"/>
          <a:sy n="90" d="100"/>
        </p:scale>
        <p:origin x="-1122" y="-20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122B95-1F01-4574-AD2D-8428868D72B0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4B24F0E-9002-4617-8019-24C115F1D27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71768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46D1B4-6422-4D50-8220-5C88400CD666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0624B-D2E0-47DA-A26C-8C36B047E7B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867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46D1B4-6422-4D50-8220-5C88400CD666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0624B-D2E0-47DA-A26C-8C36B047E7B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5169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46D1B4-6422-4D50-8220-5C88400CD666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0624B-D2E0-47DA-A26C-8C36B047E7B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37819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46D1B4-6422-4D50-8220-5C88400CD666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0624B-D2E0-47DA-A26C-8C36B047E7B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781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46D1B4-6422-4D50-8220-5C88400CD666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0624B-D2E0-47DA-A26C-8C36B047E7B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967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46D1B4-6422-4D50-8220-5C88400CD666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0624B-D2E0-47DA-A26C-8C36B047E7B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06272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46D1B4-6422-4D50-8220-5C88400CD666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0624B-D2E0-47DA-A26C-8C36B047E7B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114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46D1B4-6422-4D50-8220-5C88400CD666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0624B-D2E0-47DA-A26C-8C36B047E7B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44187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46D1B4-6422-4D50-8220-5C88400CD666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0624B-D2E0-47DA-A26C-8C36B047E7B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93146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46D1B4-6422-4D50-8220-5C88400CD666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0624B-D2E0-47DA-A26C-8C36B047E7B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2258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46D1B4-6422-4D50-8220-5C88400CD666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0624B-D2E0-47DA-A26C-8C36B047E7B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115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46D1B4-6422-4D50-8220-5C88400CD666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E0624B-D2E0-47DA-A26C-8C36B047E7B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542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1 Grupo"/>
          <p:cNvGrpSpPr/>
          <p:nvPr/>
        </p:nvGrpSpPr>
        <p:grpSpPr>
          <a:xfrm>
            <a:off x="1221705" y="78947"/>
            <a:ext cx="10148781" cy="6634986"/>
            <a:chOff x="1221705" y="78947"/>
            <a:chExt cx="10148781" cy="6634986"/>
          </a:xfrm>
        </p:grpSpPr>
        <p:grpSp>
          <p:nvGrpSpPr>
            <p:cNvPr id="4" name="Grupo 3"/>
            <p:cNvGrpSpPr/>
            <p:nvPr/>
          </p:nvGrpSpPr>
          <p:grpSpPr>
            <a:xfrm>
              <a:off x="1221705" y="590115"/>
              <a:ext cx="9117190" cy="6123818"/>
              <a:chOff x="436015" y="14172"/>
              <a:chExt cx="10125807" cy="6815527"/>
            </a:xfrm>
          </p:grpSpPr>
          <p:sp>
            <p:nvSpPr>
              <p:cNvPr id="5" name="Rectángulo 4"/>
              <p:cNvSpPr/>
              <p:nvPr/>
            </p:nvSpPr>
            <p:spPr>
              <a:xfrm>
                <a:off x="1576552" y="5598776"/>
                <a:ext cx="8313406" cy="35685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" name="CuadroTexto 5"/>
              <p:cNvSpPr txBox="1"/>
              <p:nvPr/>
            </p:nvSpPr>
            <p:spPr>
              <a:xfrm>
                <a:off x="4927718" y="6418650"/>
                <a:ext cx="2264085" cy="41104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s-E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RQr2.0-Chr04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Rectángulo 6"/>
              <p:cNvSpPr/>
              <p:nvPr/>
            </p:nvSpPr>
            <p:spPr>
              <a:xfrm>
                <a:off x="743224" y="558481"/>
                <a:ext cx="936164" cy="519067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" name="CuadroTexto 7"/>
              <p:cNvSpPr txBox="1"/>
              <p:nvPr/>
            </p:nvSpPr>
            <p:spPr>
              <a:xfrm rot="16200000">
                <a:off x="-557478" y="2681298"/>
                <a:ext cx="2397175" cy="41019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s-E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.anomalus-Chr07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CuadroTexto 8"/>
              <p:cNvSpPr txBox="1"/>
              <p:nvPr/>
            </p:nvSpPr>
            <p:spPr>
              <a:xfrm rot="16200000">
                <a:off x="1288482" y="5874526"/>
                <a:ext cx="853143" cy="3076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asnip-40</a:t>
                </a:r>
              </a:p>
            </p:txBody>
          </p:sp>
          <p:sp>
            <p:nvSpPr>
              <p:cNvPr id="10" name="CuadroTexto 9"/>
              <p:cNvSpPr txBox="1"/>
              <p:nvPr/>
            </p:nvSpPr>
            <p:spPr>
              <a:xfrm rot="16200000">
                <a:off x="9938612" y="5913799"/>
                <a:ext cx="938778" cy="3076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asnip-105</a:t>
                </a:r>
              </a:p>
            </p:txBody>
          </p:sp>
          <p:sp>
            <p:nvSpPr>
              <p:cNvPr id="11" name="CuadroTexto 10"/>
              <p:cNvSpPr txBox="1"/>
              <p:nvPr/>
            </p:nvSpPr>
            <p:spPr>
              <a:xfrm>
                <a:off x="911940" y="5460276"/>
                <a:ext cx="851360" cy="3082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asnip-40</a:t>
                </a:r>
              </a:p>
            </p:txBody>
          </p:sp>
          <p:sp>
            <p:nvSpPr>
              <p:cNvPr id="12" name="CuadroTexto 11"/>
              <p:cNvSpPr txBox="1"/>
              <p:nvPr/>
            </p:nvSpPr>
            <p:spPr>
              <a:xfrm>
                <a:off x="872666" y="14172"/>
                <a:ext cx="936816" cy="3082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asnip-105</a:t>
                </a:r>
              </a:p>
            </p:txBody>
          </p:sp>
        </p:grpSp>
        <p:pic>
          <p:nvPicPr>
            <p:cNvPr id="13" name="Marcador de contenido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462" t="14409" b="15692"/>
            <a:stretch/>
          </p:blipFill>
          <p:spPr>
            <a:xfrm>
              <a:off x="2376160" y="590115"/>
              <a:ext cx="8994326" cy="5022000"/>
            </a:xfrm>
            <a:prstGeom prst="rect">
              <a:avLst/>
            </a:prstGeom>
          </p:spPr>
        </p:pic>
        <p:sp>
          <p:nvSpPr>
            <p:cNvPr id="14" name="Título 1"/>
            <p:cNvSpPr txBox="1">
              <a:spLocks/>
            </p:cNvSpPr>
            <p:nvPr/>
          </p:nvSpPr>
          <p:spPr>
            <a:xfrm>
              <a:off x="1284006" y="78947"/>
              <a:ext cx="9591634" cy="294759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Autofit/>
            </a:bodyPr>
            <a:lstStyle>
              <a:lvl1pPr algn="l" defTabSz="9144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s-ES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1A. </a:t>
              </a:r>
              <a:r>
                <a:rPr lang="es-ES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RQr2.0-Chr04 </a:t>
              </a:r>
              <a:r>
                <a:rPr lang="es-E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rom</a:t>
              </a:r>
              <a:r>
                <a: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asnip-40 to Iasnip-105 vs </a:t>
              </a:r>
              <a:r>
                <a:rPr lang="es-ES" sz="16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s-ES" sz="16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anomalus</a:t>
              </a:r>
              <a:r>
                <a:rPr lang="es-ES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Chr07 </a:t>
              </a:r>
              <a:r>
                <a:rPr lang="es-E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rom</a:t>
              </a:r>
              <a:r>
                <a: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asnip-40 to Iasnip-105 </a:t>
              </a:r>
              <a:endParaRPr 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CuadroTexto 14"/>
            <p:cNvSpPr txBox="1"/>
            <p:nvPr/>
          </p:nvSpPr>
          <p:spPr>
            <a:xfrm rot="16200000">
              <a:off x="4486334" y="5879008"/>
              <a:ext cx="7665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asnip-41</a:t>
              </a:r>
            </a:p>
          </p:txBody>
        </p:sp>
        <p:sp>
          <p:nvSpPr>
            <p:cNvPr id="16" name="CuadroTexto 15"/>
            <p:cNvSpPr txBox="1"/>
            <p:nvPr/>
          </p:nvSpPr>
          <p:spPr>
            <a:xfrm rot="16200000">
              <a:off x="5746894" y="5898243"/>
              <a:ext cx="8435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asnip-100</a:t>
              </a:r>
            </a:p>
          </p:txBody>
        </p:sp>
        <p:sp>
          <p:nvSpPr>
            <p:cNvPr id="17" name="CuadroTexto 16"/>
            <p:cNvSpPr txBox="1"/>
            <p:nvPr/>
          </p:nvSpPr>
          <p:spPr>
            <a:xfrm>
              <a:off x="1563186" y="2924534"/>
              <a:ext cx="8435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asnip-100</a:t>
              </a:r>
            </a:p>
          </p:txBody>
        </p:sp>
        <p:sp>
          <p:nvSpPr>
            <p:cNvPr id="3" name="CuadroTexto 2">
              <a:extLst>
                <a:ext uri="{FF2B5EF4-FFF2-40B4-BE49-F238E27FC236}">
                  <a16:creationId xmlns="" xmlns:a16="http://schemas.microsoft.com/office/drawing/2014/main" id="{A2FF4715-7CC5-14CF-E3CD-F9C8D36B4899}"/>
                </a:ext>
              </a:extLst>
            </p:cNvPr>
            <p:cNvSpPr txBox="1"/>
            <p:nvPr/>
          </p:nvSpPr>
          <p:spPr>
            <a:xfrm rot="16200000">
              <a:off x="9614152" y="5890698"/>
              <a:ext cx="8435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asnip-47</a:t>
              </a:r>
            </a:p>
          </p:txBody>
        </p:sp>
        <p:sp>
          <p:nvSpPr>
            <p:cNvPr id="18" name="CuadroTexto 17">
              <a:extLst>
                <a:ext uri="{FF2B5EF4-FFF2-40B4-BE49-F238E27FC236}">
                  <a16:creationId xmlns="" xmlns:a16="http://schemas.microsoft.com/office/drawing/2014/main" id="{9D3EAD8B-03CB-68A8-C373-58A443E2C90D}"/>
                </a:ext>
              </a:extLst>
            </p:cNvPr>
            <p:cNvSpPr txBox="1"/>
            <p:nvPr/>
          </p:nvSpPr>
          <p:spPr>
            <a:xfrm rot="16200000">
              <a:off x="8176620" y="5855410"/>
              <a:ext cx="8435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asnip-28</a:t>
              </a:r>
            </a:p>
          </p:txBody>
        </p:sp>
        <p:sp>
          <p:nvSpPr>
            <p:cNvPr id="20" name="CuadroTexto 19">
              <a:extLst>
                <a:ext uri="{FF2B5EF4-FFF2-40B4-BE49-F238E27FC236}">
                  <a16:creationId xmlns="" xmlns:a16="http://schemas.microsoft.com/office/drawing/2014/main" id="{714381CA-796A-2FD0-7AE2-D11B65BE2A40}"/>
                </a:ext>
              </a:extLst>
            </p:cNvPr>
            <p:cNvSpPr txBox="1"/>
            <p:nvPr/>
          </p:nvSpPr>
          <p:spPr>
            <a:xfrm>
              <a:off x="1611751" y="780070"/>
              <a:ext cx="7665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asnip-47</a:t>
              </a:r>
            </a:p>
          </p:txBody>
        </p:sp>
        <p:sp>
          <p:nvSpPr>
            <p:cNvPr id="21" name="CuadroTexto 20">
              <a:extLst>
                <a:ext uri="{FF2B5EF4-FFF2-40B4-BE49-F238E27FC236}">
                  <a16:creationId xmlns="" xmlns:a16="http://schemas.microsoft.com/office/drawing/2014/main" id="{AA118015-97FF-8460-3487-D09CD7767E03}"/>
                </a:ext>
              </a:extLst>
            </p:cNvPr>
            <p:cNvSpPr txBox="1"/>
            <p:nvPr/>
          </p:nvSpPr>
          <p:spPr>
            <a:xfrm>
              <a:off x="1650224" y="1759220"/>
              <a:ext cx="7665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asnip-28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481154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/>
          <p:cNvGrpSpPr/>
          <p:nvPr/>
        </p:nvGrpSpPr>
        <p:grpSpPr>
          <a:xfrm>
            <a:off x="1080333" y="500038"/>
            <a:ext cx="8368858" cy="5965335"/>
            <a:chOff x="414100" y="106676"/>
            <a:chExt cx="9804231" cy="6708850"/>
          </a:xfrm>
        </p:grpSpPr>
        <p:grpSp>
          <p:nvGrpSpPr>
            <p:cNvPr id="5" name="Grupo 4"/>
            <p:cNvGrpSpPr/>
            <p:nvPr/>
          </p:nvGrpSpPr>
          <p:grpSpPr>
            <a:xfrm>
              <a:off x="414100" y="106676"/>
              <a:ext cx="9804231" cy="6708850"/>
              <a:chOff x="414100" y="106676"/>
              <a:chExt cx="9804231" cy="6708850"/>
            </a:xfrm>
          </p:grpSpPr>
          <p:sp>
            <p:nvSpPr>
              <p:cNvPr id="10" name="Rectángulo 9"/>
              <p:cNvSpPr/>
              <p:nvPr/>
            </p:nvSpPr>
            <p:spPr>
              <a:xfrm>
                <a:off x="1659194" y="6061587"/>
                <a:ext cx="213851" cy="16223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Rectángulo 10"/>
              <p:cNvSpPr/>
              <p:nvPr/>
            </p:nvSpPr>
            <p:spPr>
              <a:xfrm>
                <a:off x="3551904" y="6061587"/>
                <a:ext cx="710380" cy="16223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" name="Rectángulo 11"/>
              <p:cNvSpPr/>
              <p:nvPr/>
            </p:nvSpPr>
            <p:spPr>
              <a:xfrm>
                <a:off x="5665839" y="6061587"/>
                <a:ext cx="710380" cy="16223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" name="Rectángulo 12"/>
              <p:cNvSpPr/>
              <p:nvPr/>
            </p:nvSpPr>
            <p:spPr>
              <a:xfrm>
                <a:off x="7863349" y="6061587"/>
                <a:ext cx="710380" cy="16223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" name="Rectángulo 13"/>
              <p:cNvSpPr/>
              <p:nvPr/>
            </p:nvSpPr>
            <p:spPr>
              <a:xfrm>
                <a:off x="3522407" y="5987331"/>
                <a:ext cx="710380" cy="23648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" name="Rectángulo 14"/>
              <p:cNvSpPr/>
              <p:nvPr/>
            </p:nvSpPr>
            <p:spPr>
              <a:xfrm>
                <a:off x="5585953" y="5987330"/>
                <a:ext cx="710380" cy="23648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" name="Rectángulo 15"/>
              <p:cNvSpPr/>
              <p:nvPr/>
            </p:nvSpPr>
            <p:spPr>
              <a:xfrm>
                <a:off x="7720065" y="5987330"/>
                <a:ext cx="710380" cy="23648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" name="Rectángulo 16"/>
              <p:cNvSpPr/>
              <p:nvPr/>
            </p:nvSpPr>
            <p:spPr>
              <a:xfrm>
                <a:off x="802134" y="4335207"/>
                <a:ext cx="921158" cy="23648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" name="Rectángulo 17"/>
              <p:cNvSpPr/>
              <p:nvPr/>
            </p:nvSpPr>
            <p:spPr>
              <a:xfrm>
                <a:off x="802134" y="2845314"/>
                <a:ext cx="921158" cy="23648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" name="Rectángulo 18"/>
              <p:cNvSpPr/>
              <p:nvPr/>
            </p:nvSpPr>
            <p:spPr>
              <a:xfrm>
                <a:off x="802134" y="1305133"/>
                <a:ext cx="921158" cy="23648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Rectángulo 19"/>
              <p:cNvSpPr/>
              <p:nvPr/>
            </p:nvSpPr>
            <p:spPr>
              <a:xfrm>
                <a:off x="614579" y="5875765"/>
                <a:ext cx="921158" cy="23648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" name="CuadroTexto 20"/>
              <p:cNvSpPr txBox="1"/>
              <p:nvPr/>
            </p:nvSpPr>
            <p:spPr>
              <a:xfrm rot="16200000">
                <a:off x="1376137" y="6141798"/>
                <a:ext cx="862100" cy="3245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asnip-40</a:t>
                </a:r>
              </a:p>
            </p:txBody>
          </p:sp>
          <p:sp>
            <p:nvSpPr>
              <p:cNvPr id="22" name="CuadroTexto 21"/>
              <p:cNvSpPr txBox="1"/>
              <p:nvPr/>
            </p:nvSpPr>
            <p:spPr>
              <a:xfrm rot="16200000">
                <a:off x="9581760" y="6178955"/>
                <a:ext cx="948634" cy="3245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asnip-105</a:t>
                </a:r>
              </a:p>
            </p:txBody>
          </p:sp>
          <p:sp>
            <p:nvSpPr>
              <p:cNvPr id="23" name="CuadroTexto 22"/>
              <p:cNvSpPr txBox="1"/>
              <p:nvPr/>
            </p:nvSpPr>
            <p:spPr>
              <a:xfrm>
                <a:off x="938524" y="106676"/>
                <a:ext cx="988173" cy="3115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asnip-105</a:t>
                </a:r>
              </a:p>
            </p:txBody>
          </p:sp>
          <p:sp>
            <p:nvSpPr>
              <p:cNvPr id="27" name="CuadroTexto 26"/>
              <p:cNvSpPr txBox="1"/>
              <p:nvPr/>
            </p:nvSpPr>
            <p:spPr>
              <a:xfrm rot="16200000">
                <a:off x="-502632" y="2887730"/>
                <a:ext cx="2266141" cy="4326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s-E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RQr2.0</a:t>
                </a:r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Chr04</a:t>
                </a:r>
                <a:endParaRPr lang="es-E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CuadroTexto 27"/>
              <p:cNvSpPr txBox="1"/>
              <p:nvPr/>
            </p:nvSpPr>
            <p:spPr>
              <a:xfrm>
                <a:off x="1006901" y="5648585"/>
                <a:ext cx="898032" cy="3115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asnip-40</a:t>
                </a:r>
              </a:p>
            </p:txBody>
          </p:sp>
        </p:grpSp>
        <p:sp>
          <p:nvSpPr>
            <p:cNvPr id="6" name="CuadroTexto 5"/>
            <p:cNvSpPr txBox="1"/>
            <p:nvPr/>
          </p:nvSpPr>
          <p:spPr>
            <a:xfrm rot="16200000">
              <a:off x="4073374" y="6113854"/>
              <a:ext cx="862100" cy="3245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asnip-41</a:t>
              </a:r>
            </a:p>
          </p:txBody>
        </p:sp>
        <p:sp>
          <p:nvSpPr>
            <p:cNvPr id="7" name="CuadroTexto 6"/>
            <p:cNvSpPr txBox="1"/>
            <p:nvPr/>
          </p:nvSpPr>
          <p:spPr>
            <a:xfrm rot="16200000">
              <a:off x="5407854" y="6167525"/>
              <a:ext cx="948634" cy="3245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asnip-100</a:t>
              </a:r>
            </a:p>
          </p:txBody>
        </p:sp>
        <p:sp>
          <p:nvSpPr>
            <p:cNvPr id="8" name="CuadroTexto 7"/>
            <p:cNvSpPr txBox="1"/>
            <p:nvPr/>
          </p:nvSpPr>
          <p:spPr>
            <a:xfrm>
              <a:off x="947783" y="3869897"/>
              <a:ext cx="898032" cy="3115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asnip-41</a:t>
              </a:r>
            </a:p>
          </p:txBody>
        </p:sp>
        <p:sp>
          <p:nvSpPr>
            <p:cNvPr id="9" name="CuadroTexto 8"/>
            <p:cNvSpPr txBox="1"/>
            <p:nvPr/>
          </p:nvSpPr>
          <p:spPr>
            <a:xfrm>
              <a:off x="938524" y="2967514"/>
              <a:ext cx="988173" cy="3115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asnip-100</a:t>
              </a:r>
            </a:p>
          </p:txBody>
        </p:sp>
      </p:grpSp>
      <p:pic>
        <p:nvPicPr>
          <p:cNvPr id="29" name="Imagen 2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80" t="10416" r="10275" b="11449"/>
          <a:stretch/>
        </p:blipFill>
        <p:spPr>
          <a:xfrm>
            <a:off x="2310343" y="588853"/>
            <a:ext cx="7112090" cy="5022856"/>
          </a:xfrm>
          <a:prstGeom prst="rect">
            <a:avLst/>
          </a:prstGeom>
        </p:spPr>
      </p:pic>
      <p:sp>
        <p:nvSpPr>
          <p:cNvPr id="31" name="CuadroTexto 30"/>
          <p:cNvSpPr txBox="1"/>
          <p:nvPr/>
        </p:nvSpPr>
        <p:spPr>
          <a:xfrm>
            <a:off x="4663654" y="6405272"/>
            <a:ext cx="226915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XRQr2.0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Chr04</a:t>
            </a:r>
            <a:endParaRPr lang="en-US" dirty="0"/>
          </a:p>
        </p:txBody>
      </p:sp>
      <p:sp>
        <p:nvSpPr>
          <p:cNvPr id="33" name="Título 1"/>
          <p:cNvSpPr>
            <a:spLocks noGrp="1"/>
          </p:cNvSpPr>
          <p:nvPr>
            <p:ph type="title"/>
          </p:nvPr>
        </p:nvSpPr>
        <p:spPr>
          <a:xfrm>
            <a:off x="975648" y="78947"/>
            <a:ext cx="10506075" cy="294759"/>
          </a:xfrm>
        </p:spPr>
        <p:txBody>
          <a:bodyPr>
            <a:noAutofit/>
          </a:bodyPr>
          <a:lstStyle/>
          <a:p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s-E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B. </a:t>
            </a:r>
            <a:r>
              <a:rPr lang="es-E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RQr2.0-Chr04 </a:t>
            </a:r>
            <a:r>
              <a:rPr lang="es-E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s-E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asnip-40 to Iasnip-105 vs XRQr2.0-Chr04 </a:t>
            </a:r>
            <a:r>
              <a:rPr lang="es-E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s-E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asnip-40 to Iasnip-105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CuadroTexto 2">
            <a:extLst>
              <a:ext uri="{FF2B5EF4-FFF2-40B4-BE49-F238E27FC236}">
                <a16:creationId xmlns="" xmlns:a16="http://schemas.microsoft.com/office/drawing/2014/main" id="{2B76F6A1-B53B-F8D6-3B20-4910CEDEB054}"/>
              </a:ext>
            </a:extLst>
          </p:cNvPr>
          <p:cNvSpPr txBox="1"/>
          <p:nvPr/>
        </p:nvSpPr>
        <p:spPr>
          <a:xfrm rot="16200000">
            <a:off x="7523586" y="5905560"/>
            <a:ext cx="766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asnip-28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="" xmlns:a16="http://schemas.microsoft.com/office/drawing/2014/main" id="{7431B126-9F4C-7AA6-6DBC-B1497405CBAF}"/>
              </a:ext>
            </a:extLst>
          </p:cNvPr>
          <p:cNvSpPr txBox="1"/>
          <p:nvPr/>
        </p:nvSpPr>
        <p:spPr>
          <a:xfrm rot="16200000">
            <a:off x="8774344" y="5904939"/>
            <a:ext cx="766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asnip-47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="" xmlns:a16="http://schemas.microsoft.com/office/drawing/2014/main" id="{41BAA3D5-322A-CF71-151F-6CF5CBD0A808}"/>
              </a:ext>
            </a:extLst>
          </p:cNvPr>
          <p:cNvSpPr txBox="1"/>
          <p:nvPr/>
        </p:nvSpPr>
        <p:spPr>
          <a:xfrm>
            <a:off x="1526415" y="1506983"/>
            <a:ext cx="766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asnip-28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="" xmlns:a16="http://schemas.microsoft.com/office/drawing/2014/main" id="{AC698500-F45D-9857-6666-DC594A8589B8}"/>
              </a:ext>
            </a:extLst>
          </p:cNvPr>
          <p:cNvSpPr txBox="1"/>
          <p:nvPr/>
        </p:nvSpPr>
        <p:spPr>
          <a:xfrm>
            <a:off x="1532701" y="630655"/>
            <a:ext cx="766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asnip-47</a:t>
            </a:r>
          </a:p>
        </p:txBody>
      </p:sp>
    </p:spTree>
    <p:extLst>
      <p:ext uri="{BB962C8B-B14F-4D97-AF65-F5344CB8AC3E}">
        <p14:creationId xmlns:p14="http://schemas.microsoft.com/office/powerpoint/2010/main" val="36435289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1 Grupo"/>
          <p:cNvGrpSpPr/>
          <p:nvPr/>
        </p:nvGrpSpPr>
        <p:grpSpPr>
          <a:xfrm>
            <a:off x="922483" y="164011"/>
            <a:ext cx="10506075" cy="6636715"/>
            <a:chOff x="922483" y="164011"/>
            <a:chExt cx="10506075" cy="6636715"/>
          </a:xfrm>
        </p:grpSpPr>
        <p:grpSp>
          <p:nvGrpSpPr>
            <p:cNvPr id="4" name="Grupo 3"/>
            <p:cNvGrpSpPr/>
            <p:nvPr/>
          </p:nvGrpSpPr>
          <p:grpSpPr>
            <a:xfrm>
              <a:off x="1163878" y="526106"/>
              <a:ext cx="9198881" cy="6274620"/>
              <a:chOff x="1163878" y="526106"/>
              <a:chExt cx="9198881" cy="6274620"/>
            </a:xfrm>
          </p:grpSpPr>
          <p:grpSp>
            <p:nvGrpSpPr>
              <p:cNvPr id="5" name="Grupo 4"/>
              <p:cNvGrpSpPr/>
              <p:nvPr/>
            </p:nvGrpSpPr>
            <p:grpSpPr>
              <a:xfrm>
                <a:off x="1163878" y="526106"/>
                <a:ext cx="8253124" cy="6274620"/>
                <a:chOff x="571213" y="0"/>
                <a:chExt cx="9651036" cy="7392780"/>
              </a:xfrm>
            </p:grpSpPr>
            <p:sp>
              <p:nvSpPr>
                <p:cNvPr id="9" name="CuadroTexto 8"/>
                <p:cNvSpPr txBox="1"/>
                <p:nvPr/>
              </p:nvSpPr>
              <p:spPr>
                <a:xfrm rot="16200000">
                  <a:off x="-524733" y="2557147"/>
                  <a:ext cx="2623781" cy="43188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. anomalus</a:t>
                  </a:r>
                  <a:r>
                    <a:rPr lang="es-ES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Chr07</a:t>
                  </a:r>
                  <a:endPara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" name="CuadroTexto 9"/>
                <p:cNvSpPr txBox="1"/>
                <p:nvPr/>
              </p:nvSpPr>
              <p:spPr>
                <a:xfrm>
                  <a:off x="4765916" y="6957632"/>
                  <a:ext cx="2737423" cy="43514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. anomalus</a:t>
                  </a:r>
                  <a:r>
                    <a:rPr lang="es-ES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Chr07</a:t>
                  </a:r>
                  <a:endPara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" name="Rectángulo 10"/>
                <p:cNvSpPr/>
                <p:nvPr/>
              </p:nvSpPr>
              <p:spPr>
                <a:xfrm>
                  <a:off x="1791582" y="5995820"/>
                  <a:ext cx="8130208" cy="208722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" name="Rectángulo 11"/>
                <p:cNvSpPr/>
                <p:nvPr/>
              </p:nvSpPr>
              <p:spPr>
                <a:xfrm>
                  <a:off x="971823" y="1160061"/>
                  <a:ext cx="861526" cy="4922294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" name="CuadroTexto 12"/>
                <p:cNvSpPr txBox="1"/>
                <p:nvPr/>
              </p:nvSpPr>
              <p:spPr>
                <a:xfrm>
                  <a:off x="1061294" y="5838093"/>
                  <a:ext cx="896396" cy="3263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asnip-40</a:t>
                  </a:r>
                </a:p>
              </p:txBody>
            </p:sp>
            <p:sp>
              <p:nvSpPr>
                <p:cNvPr id="14" name="CuadroTexto 13"/>
                <p:cNvSpPr txBox="1"/>
                <p:nvPr/>
              </p:nvSpPr>
              <p:spPr>
                <a:xfrm rot="16200000">
                  <a:off x="1520269" y="6358033"/>
                  <a:ext cx="903160" cy="32391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asnip-40</a:t>
                  </a:r>
                </a:p>
              </p:txBody>
            </p:sp>
            <p:sp>
              <p:nvSpPr>
                <p:cNvPr id="15" name="CuadroTexto 14"/>
                <p:cNvSpPr txBox="1"/>
                <p:nvPr/>
              </p:nvSpPr>
              <p:spPr>
                <a:xfrm>
                  <a:off x="1022813" y="0"/>
                  <a:ext cx="986373" cy="3263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asnip-105</a:t>
                  </a:r>
                </a:p>
              </p:txBody>
            </p:sp>
            <p:sp>
              <p:nvSpPr>
                <p:cNvPr id="16" name="CuadroTexto 15"/>
                <p:cNvSpPr txBox="1"/>
                <p:nvPr/>
              </p:nvSpPr>
              <p:spPr>
                <a:xfrm rot="16200000">
                  <a:off x="9563383" y="6377929"/>
                  <a:ext cx="993816" cy="32391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asnip-105</a:t>
                  </a:r>
                </a:p>
              </p:txBody>
            </p:sp>
          </p:grpSp>
          <p:pic>
            <p:nvPicPr>
              <p:cNvPr id="6" name="Marcador de contenido 3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345" t="10153" b="11427"/>
              <a:stretch/>
            </p:blipFill>
            <p:spPr>
              <a:xfrm>
                <a:off x="2335348" y="608809"/>
                <a:ext cx="8027411" cy="5022000"/>
              </a:xfrm>
              <a:prstGeom prst="rect">
                <a:avLst/>
              </a:prstGeom>
            </p:spPr>
          </p:pic>
          <p:sp>
            <p:nvSpPr>
              <p:cNvPr id="7" name="CuadroTexto 6"/>
              <p:cNvSpPr txBox="1"/>
              <p:nvPr/>
            </p:nvSpPr>
            <p:spPr>
              <a:xfrm rot="16200000">
                <a:off x="5530603" y="5965336"/>
                <a:ext cx="843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asnip-100</a:t>
                </a:r>
              </a:p>
            </p:txBody>
          </p:sp>
          <p:sp>
            <p:nvSpPr>
              <p:cNvPr id="8" name="CuadroTexto 7"/>
              <p:cNvSpPr txBox="1"/>
              <p:nvPr/>
            </p:nvSpPr>
            <p:spPr>
              <a:xfrm>
                <a:off x="1534498" y="2931112"/>
                <a:ext cx="843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asnip-100</a:t>
                </a:r>
              </a:p>
            </p:txBody>
          </p:sp>
        </p:grpSp>
        <p:sp>
          <p:nvSpPr>
            <p:cNvPr id="17" name="Título 1"/>
            <p:cNvSpPr txBox="1">
              <a:spLocks/>
            </p:cNvSpPr>
            <p:nvPr/>
          </p:nvSpPr>
          <p:spPr>
            <a:xfrm>
              <a:off x="922483" y="164011"/>
              <a:ext cx="10506075" cy="294759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Autofit/>
            </a:bodyPr>
            <a:lstStyle>
              <a:lvl1pPr algn="l" defTabSz="9144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s-E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</a:t>
              </a:r>
              <a:r>
                <a:rPr lang="es-ES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1C. </a:t>
              </a:r>
              <a:r>
                <a:rPr lang="es-ES" sz="16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s-ES" sz="16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anomalus</a:t>
              </a:r>
              <a:r>
                <a:rPr lang="es-ES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Chr07 </a:t>
              </a:r>
              <a:r>
                <a:rPr lang="es-E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rom</a:t>
              </a:r>
              <a:r>
                <a: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asnip-40 to Iasnip-105 vs </a:t>
              </a:r>
              <a:r>
                <a:rPr lang="es-ES" sz="16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s-ES" sz="16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anomalus</a:t>
              </a:r>
              <a:r>
                <a:rPr lang="es-ES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Chr07 </a:t>
              </a:r>
              <a:r>
                <a:rPr lang="es-E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rom</a:t>
              </a:r>
              <a:r>
                <a: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asnip-40 to Iasnip-105 </a:t>
              </a:r>
              <a:endParaRPr 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CuadroTexto 2">
              <a:extLst>
                <a:ext uri="{FF2B5EF4-FFF2-40B4-BE49-F238E27FC236}">
                  <a16:creationId xmlns="" xmlns:a16="http://schemas.microsoft.com/office/drawing/2014/main" id="{FE66D588-5D3B-F2A0-B623-EB4ADCF24099}"/>
                </a:ext>
              </a:extLst>
            </p:cNvPr>
            <p:cNvSpPr txBox="1"/>
            <p:nvPr/>
          </p:nvSpPr>
          <p:spPr>
            <a:xfrm rot="16200000">
              <a:off x="7209169" y="5945173"/>
              <a:ext cx="7665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asnip-28</a:t>
              </a:r>
            </a:p>
          </p:txBody>
        </p:sp>
        <p:sp>
          <p:nvSpPr>
            <p:cNvPr id="18" name="CuadroTexto 17">
              <a:extLst>
                <a:ext uri="{FF2B5EF4-FFF2-40B4-BE49-F238E27FC236}">
                  <a16:creationId xmlns="" xmlns:a16="http://schemas.microsoft.com/office/drawing/2014/main" id="{91E2566B-CB43-9322-78CE-FBD4E6910A07}"/>
                </a:ext>
              </a:extLst>
            </p:cNvPr>
            <p:cNvSpPr txBox="1"/>
            <p:nvPr/>
          </p:nvSpPr>
          <p:spPr>
            <a:xfrm rot="16200000">
              <a:off x="8572263" y="5975967"/>
              <a:ext cx="7665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asnip-47</a:t>
              </a:r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="" xmlns:a16="http://schemas.microsoft.com/office/drawing/2014/main" id="{7BD134C5-6187-14DF-7BF7-45E221AB175A}"/>
                </a:ext>
              </a:extLst>
            </p:cNvPr>
            <p:cNvSpPr txBox="1"/>
            <p:nvPr/>
          </p:nvSpPr>
          <p:spPr>
            <a:xfrm>
              <a:off x="1550066" y="1766301"/>
              <a:ext cx="7665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asnip-28</a:t>
              </a:r>
            </a:p>
          </p:txBody>
        </p:sp>
        <p:sp>
          <p:nvSpPr>
            <p:cNvPr id="20" name="CuadroTexto 19">
              <a:extLst>
                <a:ext uri="{FF2B5EF4-FFF2-40B4-BE49-F238E27FC236}">
                  <a16:creationId xmlns="" xmlns:a16="http://schemas.microsoft.com/office/drawing/2014/main" id="{E5F1D83F-D168-FB31-18CF-BEB46D5724CC}"/>
                </a:ext>
              </a:extLst>
            </p:cNvPr>
            <p:cNvSpPr txBox="1"/>
            <p:nvPr/>
          </p:nvSpPr>
          <p:spPr>
            <a:xfrm>
              <a:off x="1568791" y="798476"/>
              <a:ext cx="7665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asnip-47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7922351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6</TotalTime>
  <Words>93</Words>
  <Application>Microsoft Office PowerPoint</Application>
  <PresentationFormat>Personalizado</PresentationFormat>
  <Paragraphs>42</Paragraphs>
  <Slides>3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4" baseType="lpstr">
      <vt:lpstr>Tema de Office</vt:lpstr>
      <vt:lpstr>Presentación de PowerPoint</vt:lpstr>
      <vt:lpstr>Figure S1B. XRQr2.0-Chr04 from Iasnip-40 to Iasnip-105 vs XRQr2.0-Chr04 from Iasnip-40 to Iasnip-105</vt:lpstr>
      <vt:lpstr>Presentación de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Usuario</dc:creator>
  <cp:lastModifiedBy>Bego</cp:lastModifiedBy>
  <cp:revision>22</cp:revision>
  <dcterms:created xsi:type="dcterms:W3CDTF">2023-03-15T16:29:32Z</dcterms:created>
  <dcterms:modified xsi:type="dcterms:W3CDTF">2023-07-27T14:21:34Z</dcterms:modified>
</cp:coreProperties>
</file>